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89598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679400" y="685440"/>
            <a:ext cx="34992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FE81DF-EAC9-42D9-8647-B0994D564F4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sldImg"/>
          </p:nvPr>
        </p:nvSpPr>
        <p:spPr>
          <a:xfrm>
            <a:off x="1679400" y="685800"/>
            <a:ext cx="3499200" cy="3429000"/>
          </a:xfrm>
          <a:prstGeom prst="rect">
            <a:avLst/>
          </a:prstGeom>
          <a:ln w="0">
            <a:noFill/>
          </a:ln>
        </p:spPr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FDAFBA-37DC-459B-87BF-105BB170C51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4F23A-A9C7-440D-A97A-6DFDC93E9D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2090880"/>
            <a:ext cx="822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5180760"/>
            <a:ext cx="822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41221E-5F89-446A-A11C-F1569BE287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209088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209088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518076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518076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7CE15-B7AB-4738-B316-4923BD4966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2090880"/>
            <a:ext cx="264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2090880"/>
            <a:ext cx="264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2090880"/>
            <a:ext cx="264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5180760"/>
            <a:ext cx="264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5180760"/>
            <a:ext cx="264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5180760"/>
            <a:ext cx="264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0B6FC-5E1E-4099-966F-FCED159AED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2090880"/>
            <a:ext cx="8229600" cy="59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D5C07-9447-4AE8-BAD1-8854674621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2090880"/>
            <a:ext cx="8229600" cy="59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74344-C3EE-49A9-A91E-AD72A777E1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2090880"/>
            <a:ext cx="4015800" cy="59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2090880"/>
            <a:ext cx="4015800" cy="59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A5298-703E-43F7-B9D7-4E9DEA6BE0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6928D-5A55-4D0F-A4A0-F056454FA7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358560"/>
            <a:ext cx="8229600" cy="6924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215A64-E2D8-4857-91AF-A96FF8D14C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209088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2090880"/>
            <a:ext cx="4015800" cy="59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518076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CA9BB2-FA09-4A42-A43B-9B31F784E3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2090880"/>
            <a:ext cx="4015800" cy="59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209088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518076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A973A-051B-4303-A169-924A57ADDA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209088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2090880"/>
            <a:ext cx="40158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5180760"/>
            <a:ext cx="8229600" cy="282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1751D-1691-4DC4-AA1D-5C41B12BEC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358560"/>
            <a:ext cx="8229600" cy="1493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2090880"/>
            <a:ext cx="8229600" cy="59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83055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830556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830556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F0B79D-E71F-49D6-8DE0-C72CE95724C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32"/>
          <p:cNvGrpSpPr/>
          <p:nvPr/>
        </p:nvGrpSpPr>
        <p:grpSpPr>
          <a:xfrm>
            <a:off x="133200" y="114480"/>
            <a:ext cx="8839440" cy="8754480"/>
            <a:chOff x="133200" y="114480"/>
            <a:chExt cx="8839440" cy="8754480"/>
          </a:xfrm>
        </p:grpSpPr>
        <p:grpSp>
          <p:nvGrpSpPr>
            <p:cNvPr id="49" name="Group 129"/>
            <p:cNvGrpSpPr/>
            <p:nvPr/>
          </p:nvGrpSpPr>
          <p:grpSpPr>
            <a:xfrm>
              <a:off x="151920" y="114480"/>
              <a:ext cx="8787240" cy="6187680"/>
              <a:chOff x="151920" y="114480"/>
              <a:chExt cx="8787240" cy="6187680"/>
            </a:xfrm>
          </p:grpSpPr>
          <p:pic>
            <p:nvPicPr>
              <p:cNvPr id="50" name="Picture 2" descr=""/>
              <p:cNvPicPr/>
              <p:nvPr/>
            </p:nvPicPr>
            <p:blipFill>
              <a:blip r:embed="rId1"/>
              <a:srcRect l="1021" t="86941" r="9218" b="-2470"/>
              <a:stretch/>
            </p:blipFill>
            <p:spPr>
              <a:xfrm>
                <a:off x="1642320" y="4991040"/>
                <a:ext cx="7239600" cy="100116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51" name="TextBox 131"/>
              <p:cNvSpPr/>
              <p:nvPr/>
            </p:nvSpPr>
            <p:spPr>
              <a:xfrm>
                <a:off x="1762920" y="114480"/>
                <a:ext cx="1441440" cy="182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Dd2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2" name="Group 32"/>
              <p:cNvGrpSpPr/>
              <p:nvPr/>
            </p:nvGrpSpPr>
            <p:grpSpPr>
              <a:xfrm>
                <a:off x="4520880" y="218880"/>
                <a:ext cx="4399560" cy="3014280"/>
                <a:chOff x="4520880" y="218880"/>
                <a:chExt cx="4399560" cy="3014280"/>
              </a:xfrm>
            </p:grpSpPr>
            <p:pic>
              <p:nvPicPr>
                <p:cNvPr id="53" name="Picture 4" descr=""/>
                <p:cNvPicPr/>
                <p:nvPr/>
              </p:nvPicPr>
              <p:blipFill>
                <a:blip r:embed="rId2"/>
                <a:srcRect l="10070" t="12759" r="0" b="10003"/>
                <a:stretch/>
              </p:blipFill>
              <p:spPr>
                <a:xfrm>
                  <a:off x="5205240" y="340560"/>
                  <a:ext cx="3658320" cy="25092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4" name="TextBox 151"/>
                <p:cNvSpPr/>
                <p:nvPr/>
              </p:nvSpPr>
              <p:spPr>
                <a:xfrm>
                  <a:off x="5205240" y="2719800"/>
                  <a:ext cx="3715200" cy="1828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650 k        1700 k        1750 k       1800 k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TextBox 152"/>
                <p:cNvSpPr/>
                <p:nvPr/>
              </p:nvSpPr>
              <p:spPr>
                <a:xfrm>
                  <a:off x="5803920" y="2956680"/>
                  <a:ext cx="2719800" cy="2764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hromosome posi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TextBox 153"/>
                <p:cNvSpPr/>
                <p:nvPr/>
              </p:nvSpPr>
              <p:spPr>
                <a:xfrm rot="16200000">
                  <a:off x="3922920" y="1149480"/>
                  <a:ext cx="1585800" cy="390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GH signal intensity [Log</a:t>
                  </a:r>
                  <a:r>
                    <a:rPr b="0" lang="en-US" sz="12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 ratio]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TextBox 154"/>
                <p:cNvSpPr/>
                <p:nvPr/>
              </p:nvSpPr>
              <p:spPr>
                <a:xfrm rot="16200000">
                  <a:off x="3942360" y="1316160"/>
                  <a:ext cx="2362680" cy="1677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-4          -2          0          2          4 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8" name="Group 31"/>
              <p:cNvGrpSpPr/>
              <p:nvPr/>
            </p:nvGrpSpPr>
            <p:grpSpPr>
              <a:xfrm>
                <a:off x="151920" y="218880"/>
                <a:ext cx="4430520" cy="3014280"/>
                <a:chOff x="151920" y="218880"/>
                <a:chExt cx="4430520" cy="3014280"/>
              </a:xfrm>
            </p:grpSpPr>
            <p:sp>
              <p:nvSpPr>
                <p:cNvPr id="59" name="TextBox 145"/>
                <p:cNvSpPr/>
                <p:nvPr/>
              </p:nvSpPr>
              <p:spPr>
                <a:xfrm>
                  <a:off x="1288440" y="2956680"/>
                  <a:ext cx="2719800" cy="2764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hromosome positio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TextBox 146"/>
                <p:cNvSpPr/>
                <p:nvPr/>
              </p:nvSpPr>
              <p:spPr>
                <a:xfrm rot="16200000">
                  <a:off x="-445680" y="1149480"/>
                  <a:ext cx="1585800" cy="390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GH signal intensity [Log</a:t>
                  </a:r>
                  <a:r>
                    <a:rPr b="0" lang="en-US" sz="1200" spc="-1" strike="noStrike" baseline="-25000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 ratio]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TextBox 147"/>
                <p:cNvSpPr/>
                <p:nvPr/>
              </p:nvSpPr>
              <p:spPr>
                <a:xfrm rot="16200000">
                  <a:off x="-426240" y="1316160"/>
                  <a:ext cx="2362680" cy="1677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-4          -2          0          2          4 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62" name="Picture 5" descr=""/>
                <p:cNvPicPr/>
                <p:nvPr/>
              </p:nvPicPr>
              <p:blipFill>
                <a:blip r:embed="rId3"/>
                <a:srcRect l="10070" t="12759" r="0" b="11378"/>
                <a:stretch/>
              </p:blipFill>
              <p:spPr>
                <a:xfrm>
                  <a:off x="829080" y="370080"/>
                  <a:ext cx="3658320" cy="24645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3" name="TextBox 149"/>
                <p:cNvSpPr/>
                <p:nvPr/>
              </p:nvSpPr>
              <p:spPr>
                <a:xfrm>
                  <a:off x="867240" y="2763360"/>
                  <a:ext cx="3715200" cy="18288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650 k        1700 k        1750 k       1800 k 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4" name="TextBox 134"/>
              <p:cNvSpPr/>
              <p:nvPr/>
            </p:nvSpPr>
            <p:spPr>
              <a:xfrm>
                <a:off x="6252840" y="114480"/>
                <a:ext cx="1441440" cy="182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 u="sng">
                    <a:solidFill>
                      <a:srgbClr val="000000"/>
                    </a:solidFill>
                    <a:uFillTx/>
                    <a:latin typeface="Arial"/>
                  </a:rPr>
                  <a:t>7C126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5" name="Picture 7" descr=""/>
              <p:cNvPicPr/>
              <p:nvPr/>
            </p:nvPicPr>
            <p:blipFill>
              <a:blip r:embed="rId4"/>
              <a:srcRect l="0" t="37104" r="0" b="48625"/>
              <a:stretch/>
            </p:blipFill>
            <p:spPr>
              <a:xfrm>
                <a:off x="251280" y="3620160"/>
                <a:ext cx="8687880" cy="990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6" name="Rectangle 44"/>
              <p:cNvSpPr/>
              <p:nvPr/>
            </p:nvSpPr>
            <p:spPr>
              <a:xfrm>
                <a:off x="5681520" y="3610080"/>
                <a:ext cx="1571760" cy="69516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Straight Connector 45"/>
              <p:cNvSpPr/>
              <p:nvPr/>
            </p:nvSpPr>
            <p:spPr>
              <a:xfrm flipH="1">
                <a:off x="1642320" y="4304880"/>
                <a:ext cx="4038840" cy="68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Straight Connector 46"/>
              <p:cNvSpPr/>
              <p:nvPr/>
            </p:nvSpPr>
            <p:spPr>
              <a:xfrm>
                <a:off x="7246800" y="4305600"/>
                <a:ext cx="1635120" cy="685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Straight Connector 47"/>
              <p:cNvSpPr/>
              <p:nvPr/>
            </p:nvSpPr>
            <p:spPr>
              <a:xfrm>
                <a:off x="740880" y="4227840"/>
                <a:ext cx="77745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Box 140"/>
              <p:cNvSpPr/>
              <p:nvPr/>
            </p:nvSpPr>
            <p:spPr>
              <a:xfrm>
                <a:off x="3998160" y="6025680"/>
                <a:ext cx="2719440" cy="276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hromosome posit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Straight Connector 49"/>
              <p:cNvSpPr/>
              <p:nvPr/>
            </p:nvSpPr>
            <p:spPr>
              <a:xfrm>
                <a:off x="1664640" y="5577120"/>
                <a:ext cx="72014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Straight Connector 50"/>
              <p:cNvSpPr/>
              <p:nvPr/>
            </p:nvSpPr>
            <p:spPr>
              <a:xfrm>
                <a:off x="4763880" y="4915080"/>
                <a:ext cx="685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triangle" w="med"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Straight Connector 51"/>
              <p:cNvSpPr/>
              <p:nvPr/>
            </p:nvSpPr>
            <p:spPr>
              <a:xfrm>
                <a:off x="1871280" y="2324160"/>
                <a:ext cx="1143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triangle" w="med"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Straight Connector 52"/>
              <p:cNvSpPr/>
              <p:nvPr/>
            </p:nvSpPr>
            <p:spPr>
              <a:xfrm>
                <a:off x="6319800" y="2324160"/>
                <a:ext cx="1143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headEnd len="med" type="triangle" w="med"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" name="Rectangle 1"/>
            <p:cNvSpPr/>
            <p:nvPr/>
          </p:nvSpPr>
          <p:spPr>
            <a:xfrm>
              <a:off x="133200" y="6122880"/>
              <a:ext cx="8839440" cy="27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152280" bIns="38160" anchor="ctr">
              <a:spAutoFit/>
            </a:bodyPr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dditional file 12  – </a:t>
              </a: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Recurrent </a:t>
              </a:r>
              <a:r>
                <a:rPr b="1" i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e novo</a:t>
              </a: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CNV in a multiallelic region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We directly examined the parental SNP allele inheritance [69] within a recurrent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de novo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CNV in Chr 12 in the progeny clone 7C126. The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de novo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CNV region is demarcated by an arrow (A) scatter plot of parent CNV profile, Dd2 parent is compared with HB3 parent; (B) scatter plot of progeny CNV profile, progeny is compared with HB3 parent. (C) SNP map of Chr 12 [69]. Each bar of the SNP map denotes a single SNP allele demarcated by the parent allele. The parent allele is highlighted by red (Dd2) and green (HB3). The SNP allele profile which overlaps the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de novo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Calibri"/>
                </a:rPr>
                <a:t> CNV region confirms a HB3 allelic region interspersed within a larger Dd2 allelic region (highlighted by arrow), suggesting a potential gene conversion or double crossover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5"/>
            <p:cNvSpPr/>
            <p:nvPr/>
          </p:nvSpPr>
          <p:spPr>
            <a:xfrm>
              <a:off x="151920" y="155520"/>
              <a:ext cx="2919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5"/>
            <p:cNvSpPr/>
            <p:nvPr/>
          </p:nvSpPr>
          <p:spPr>
            <a:xfrm>
              <a:off x="4267080" y="155520"/>
              <a:ext cx="2919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5"/>
            <p:cNvSpPr/>
            <p:nvPr/>
          </p:nvSpPr>
          <p:spPr>
            <a:xfrm>
              <a:off x="151920" y="3286080"/>
              <a:ext cx="2919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Aft>
                  <a:spcPts val="1001"/>
                </a:spcAft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04T05:48:31Z</dcterms:created>
  <dc:creator>Upeka</dc:creator>
  <dc:description/>
  <dc:language>en-US</dc:language>
  <cp:lastModifiedBy>Upeka Samarakoon</cp:lastModifiedBy>
  <dcterms:modified xsi:type="dcterms:W3CDTF">2011-10-05T14:28:59Z</dcterms:modified>
  <cp:revision>7</cp:revision>
  <dc:subject/>
  <dc:title>Slide 1</dc:title>
</cp:coreProperties>
</file>